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7908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2491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2607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4169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9600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4242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7838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569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62930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36740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494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4BC7E-6439-4E61-B032-69C93D50515D}" type="datetimeFigureOut">
              <a:rPr lang="en-IN" smtClean="0"/>
              <a:t>21-11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8DA9D2-935C-4CD8-A137-62F5023B666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8446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1124744"/>
            <a:ext cx="5780970" cy="3608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13" t="33585" b="41501"/>
          <a:stretch/>
        </p:blipFill>
        <p:spPr bwMode="auto">
          <a:xfrm>
            <a:off x="6711910" y="1124744"/>
            <a:ext cx="812418" cy="110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Rectangle 7"/>
          <p:cNvSpPr/>
          <p:nvPr/>
        </p:nvSpPr>
        <p:spPr>
          <a:xfrm>
            <a:off x="251520" y="4941168"/>
            <a:ext cx="84249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S1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in %) of the individual nucleotides in high quality reads of control (BC), high temperature (BHS) and drought (BDS) RNA-Seq libraries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5184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RDWAJ</dc:creator>
  <cp:lastModifiedBy>BHARDWAJ</cp:lastModifiedBy>
  <cp:revision>1</cp:revision>
  <dcterms:created xsi:type="dcterms:W3CDTF">2014-11-21T11:47:17Z</dcterms:created>
  <dcterms:modified xsi:type="dcterms:W3CDTF">2014-11-21T11:52:43Z</dcterms:modified>
</cp:coreProperties>
</file>